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E0E9D-8B47-4CA0-8617-3882AC4585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9E496-A699-4A9D-9857-7F637B2271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882EC-58DB-4FBD-AFE0-35B0D9E69A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11D54-F371-4B57-B7BE-38EF3A7994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3ECE8-7806-42BF-8DAF-ABA046C02E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1C3A31-66C5-4274-B49E-DFC77B85C7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8EAE3-002D-4D1D-9A3C-3E1713BAE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D01F7-31E6-4D9D-BC57-2C1368687C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62924-D62C-4B4B-8E6E-E8471B3C7D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FA27F8-1793-4FD9-AC4D-41AFEE0E0B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BF55D-D49C-4569-A10B-58A86A4125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052D5-0BD5-4ACC-921D-DFCA35FAC4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DEFBD3-BF82-4AF0-8754-91DCB4E3E6CD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457200" y="1066680"/>
            <a:ext cx="8229600" cy="20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BRC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PMingLiU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PMingLiU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Homologous recombination (HR), damage checkpoint, transcription-coupled BER, regulation o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PMingLiU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transcription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RCA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R, promotion of Rad51 assembly ssDNA  (note that BRC3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RCA2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truncate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mutant cells were analyzed)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FANCD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R, damage response to DNA interstrand crosslinks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XRCC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R, promotion of Rad51 assembly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XRCC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R, promotion of Rad51 assembly, resolution of Holliday junctions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AD51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R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AD18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gulation of translesion DNA synthesis (TLS)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V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LS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ARP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ER, single strand DNA break repair, double strand DNA break repair (1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0" y="228600"/>
            <a:ext cx="9144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DNA repair genes mutated in the analyzed DT40 clone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                 Functio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Line 4"/>
          <p:cNvSpPr/>
          <p:nvPr/>
        </p:nvSpPr>
        <p:spPr>
          <a:xfrm>
            <a:off x="228600" y="990720"/>
            <a:ext cx="80773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Line 5"/>
          <p:cNvSpPr/>
          <p:nvPr/>
        </p:nvSpPr>
        <p:spPr>
          <a:xfrm>
            <a:off x="228600" y="3352680"/>
            <a:ext cx="80773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304920" y="3429000"/>
            <a:ext cx="8229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ll mutant cells were generated by gene targeting techniqu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1) Ridpath JR, Nakamura A, Tano K, Luke AM, Sonoda E, Arakawa H, et al. Cell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Deficient in the FANC/BRCA Pathway Are Hypersensitive to Plasma Levels of Formaldehyde. Cancer Res 2007;67:11117-11122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24T14:39:50Z</dcterms:created>
  <dc:creator>ADMIN</dc:creator>
  <dc:description/>
  <dc:language>en-US</dc:language>
  <cp:lastModifiedBy>Jun</cp:lastModifiedBy>
  <dcterms:modified xsi:type="dcterms:W3CDTF">2019-10-18T04:06:22Z</dcterms:modified>
  <cp:revision>4</cp:revision>
  <dc:subject/>
  <dc:title>PowerPoint Presentation</dc:title>
</cp:coreProperties>
</file>